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A6219C-28D0-7FBB-5F06-0A9FA35B10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AFF4D9-C2BF-A1AE-91F1-40237A560B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E40D5C-099C-A3C2-4E8D-6B8CE08EB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F2293D-F9A4-042F-8223-3C9457FDC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03260-2860-30BD-2E8E-4C6690DF1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83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082DD-1B6D-41D0-40B4-F7B5AC5D8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226772-620D-5115-D623-A3E615C59D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8A1F5-4F45-AC6D-8D6E-DC8F31E87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90CB9-1DA3-D68E-4262-0445A82BB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81609-D629-8719-0887-B2AF2A721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538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247798-4B69-6992-454C-CA4B228CD2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E066E5-2365-0276-2481-029E455876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0B6FB-83FC-AFB9-49A1-6F25E6D2D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D5E8A-7FBF-B1F2-F8ED-652A970EE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DEA46-FA99-ABA9-5459-3C098DB5C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950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94545-5B7E-F08F-6BE1-EC897FBDF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A5C344-980A-009E-8790-D692EDFAA0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82EE9B-9678-61F6-6762-519400710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6D13E5-9144-8935-5BD5-6C23A061C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86974-FC15-EDE6-F027-499B21D61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462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B63D4-708B-744E-D8CF-16AA9424B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5727F4-42B6-4835-BB0F-A6CF9022E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BA927-7252-905E-6539-4384AD5F1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B8B71-864B-90BF-A237-EDDAB8DFC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94A25-EB25-69D9-8D34-88A90BEEA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041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89E09-F188-C3F2-2D07-AFDC7FF94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55E71F-6176-6510-71E7-5CC7BCF551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A2AE7E-DF53-2F3F-1642-84C6CE462B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A33882-C063-338B-D02A-3C5E99130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70AD6-2A6A-E91F-7013-9026A84D7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2A0A1-0D2F-DD37-E804-F2C93B8FD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694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7DD43-ACF4-E0BF-EAC6-B66AEB413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29C15-1026-D96F-5A1C-D32E1E037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89C397-935E-6223-A80F-C2EB0B37DF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EF8A7D-B43E-7BFF-1EDE-6209D09DF1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83D2A2-64A2-20DE-7241-2F56BC22F0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597D6B-E29A-9784-8181-A0E38D6C2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2483F-A6FB-BF8B-6F44-51D59DDE9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36BB3D-E719-7DD9-53A4-19389A581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56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B7B7C-864B-2B6C-7D12-39C6EC145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B3F36B-C5B2-126F-E955-C2D33309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2AB72F-ACFD-5261-11E8-C73F9E5E2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8FF429-8470-26DF-1E22-D6D1AC029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915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A041A6-9E92-9D25-6C71-4224A6A5C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C44AE3-7EFC-CA14-E62C-D4EDE3E5B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321406-4AAC-E446-853F-501CA8DD8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8788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78274-C6C3-041E-AA75-95EA4DE6F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3BB9D1-CADD-A742-2DB6-CBF78C5B41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9E64A8-1310-5315-7903-1362EFE66A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A840E-6850-A3F7-D105-CBE513C5C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76949-D9D2-085D-5CD8-12C647312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962DBB-B051-A759-EE1C-405D67505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38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8490A-0287-3A0C-366F-95E9790C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1F8AC2-BF34-DB6B-8340-D9C7BF59D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72564C-365F-AE9C-8E1D-1A6A245C6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A1D1D7-5CC5-B5E7-4DC9-8AC5264ED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9B8DA-3F59-19E0-D3E0-5A32F30D3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36430E-CAC2-F891-8E7C-7F33B0A0D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799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B2867D-D19E-9959-13B1-692DFE5B5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811ED2-5C3A-9662-62D5-9EAFD61126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B2104-DF6C-0372-0199-37605C26CF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FA202-3DD9-A530-40F3-6EB77AFDAE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6C4AF-6A13-57C2-334D-9E98B95227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257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na&#10;&#10;Description automatically generated">
            <a:extLst>
              <a:ext uri="{FF2B5EF4-FFF2-40B4-BE49-F238E27FC236}">
                <a16:creationId xmlns:a16="http://schemas.microsoft.com/office/drawing/2014/main" id="{BF91FB62-BC87-890E-BF88-3F83775B54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746" y="2623056"/>
            <a:ext cx="4276725" cy="4038600"/>
          </a:xfrm>
          <a:prstGeom prst="rect">
            <a:avLst/>
          </a:prstGeom>
        </p:spPr>
      </p:pic>
      <p:pic>
        <p:nvPicPr>
          <p:cNvPr id="7" name="Picture 6" descr="A black line on a white surface&#10;&#10;Description automatically generated">
            <a:extLst>
              <a:ext uri="{FF2B5EF4-FFF2-40B4-BE49-F238E27FC236}">
                <a16:creationId xmlns:a16="http://schemas.microsoft.com/office/drawing/2014/main" id="{845B0913-70ED-5CB0-527D-64D4D40E3F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0647" y="2617830"/>
            <a:ext cx="4391025" cy="179070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6A4C7A06-6D49-F122-123C-F7ED60E122EA}"/>
              </a:ext>
            </a:extLst>
          </p:cNvPr>
          <p:cNvSpPr/>
          <p:nvPr/>
        </p:nvSpPr>
        <p:spPr>
          <a:xfrm>
            <a:off x="1650882" y="4304181"/>
            <a:ext cx="1651820" cy="798761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64E34F-6FF8-894A-D6A6-B62BFD318698}"/>
              </a:ext>
            </a:extLst>
          </p:cNvPr>
          <p:cNvSpPr txBox="1"/>
          <p:nvPr/>
        </p:nvSpPr>
        <p:spPr>
          <a:xfrm>
            <a:off x="4804209" y="393484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B3BC4F-E78C-45A4-1917-475F87E605BF}"/>
              </a:ext>
            </a:extLst>
          </p:cNvPr>
          <p:cNvSpPr txBox="1"/>
          <p:nvPr/>
        </p:nvSpPr>
        <p:spPr>
          <a:xfrm>
            <a:off x="4804209" y="440853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0ED5CD-DAEC-9BCA-5E4F-2543507E9928}"/>
              </a:ext>
            </a:extLst>
          </p:cNvPr>
          <p:cNvSpPr txBox="1"/>
          <p:nvPr/>
        </p:nvSpPr>
        <p:spPr>
          <a:xfrm>
            <a:off x="4804209" y="488221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C0C14B9-C5AE-F2DB-364B-4FBE7629115F}"/>
              </a:ext>
            </a:extLst>
          </p:cNvPr>
          <p:cNvSpPr txBox="1"/>
          <p:nvPr/>
        </p:nvSpPr>
        <p:spPr>
          <a:xfrm>
            <a:off x="4804209" y="529825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BDBB39-4D79-7536-C02C-54B4BE98E640}"/>
              </a:ext>
            </a:extLst>
          </p:cNvPr>
          <p:cNvSpPr txBox="1"/>
          <p:nvPr/>
        </p:nvSpPr>
        <p:spPr>
          <a:xfrm>
            <a:off x="4804209" y="600330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A0A777-8B72-BF89-2004-3FAD4ED32EC5}"/>
              </a:ext>
            </a:extLst>
          </p:cNvPr>
          <p:cNvSpPr txBox="1"/>
          <p:nvPr/>
        </p:nvSpPr>
        <p:spPr>
          <a:xfrm>
            <a:off x="4804209" y="3094287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DE94686-9833-442D-877B-46204EBAC6D4}"/>
              </a:ext>
            </a:extLst>
          </p:cNvPr>
          <p:cNvSpPr txBox="1"/>
          <p:nvPr/>
        </p:nvSpPr>
        <p:spPr>
          <a:xfrm>
            <a:off x="4804209" y="274114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3AC8FB-70E1-DAB5-FAFE-2089EBFAECD5}"/>
              </a:ext>
            </a:extLst>
          </p:cNvPr>
          <p:cNvSpPr txBox="1"/>
          <p:nvPr/>
        </p:nvSpPr>
        <p:spPr>
          <a:xfrm>
            <a:off x="1749206" y="225372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249D36-F532-DC67-93EC-4290080BE3BE}"/>
              </a:ext>
            </a:extLst>
          </p:cNvPr>
          <p:cNvSpPr txBox="1"/>
          <p:nvPr/>
        </p:nvSpPr>
        <p:spPr>
          <a:xfrm>
            <a:off x="2256504" y="225372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74D8523-5F7D-DE4E-B08D-DEA2CBF9DFD8}"/>
              </a:ext>
            </a:extLst>
          </p:cNvPr>
          <p:cNvSpPr txBox="1"/>
          <p:nvPr/>
        </p:nvSpPr>
        <p:spPr>
          <a:xfrm>
            <a:off x="2748751" y="225372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8E3AC2-2E42-1C0A-FDB3-39181A2BC900}"/>
              </a:ext>
            </a:extLst>
          </p:cNvPr>
          <p:cNvSpPr txBox="1"/>
          <p:nvPr/>
        </p:nvSpPr>
        <p:spPr>
          <a:xfrm>
            <a:off x="1840620" y="193354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A49CBC6-13E6-AAF8-887A-D647301FAEBF}"/>
              </a:ext>
            </a:extLst>
          </p:cNvPr>
          <p:cNvCxnSpPr/>
          <p:nvPr/>
        </p:nvCxnSpPr>
        <p:spPr>
          <a:xfrm>
            <a:off x="1867511" y="2253723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D07B818-B109-92D7-899E-7B854F4C0A11}"/>
              </a:ext>
            </a:extLst>
          </p:cNvPr>
          <p:cNvSpPr txBox="1"/>
          <p:nvPr/>
        </p:nvSpPr>
        <p:spPr>
          <a:xfrm>
            <a:off x="8115593" y="227798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67A4298-71D9-7176-AE09-9DA87BD2D13C}"/>
              </a:ext>
            </a:extLst>
          </p:cNvPr>
          <p:cNvSpPr txBox="1"/>
          <p:nvPr/>
        </p:nvSpPr>
        <p:spPr>
          <a:xfrm>
            <a:off x="8622891" y="227798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B72D8B8-0BB9-2641-9942-7328593A5288}"/>
              </a:ext>
            </a:extLst>
          </p:cNvPr>
          <p:cNvSpPr txBox="1"/>
          <p:nvPr/>
        </p:nvSpPr>
        <p:spPr>
          <a:xfrm>
            <a:off x="9115138" y="227798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A6FED64-F2E1-1F5F-1895-D06D7AF6C3BF}"/>
              </a:ext>
            </a:extLst>
          </p:cNvPr>
          <p:cNvSpPr txBox="1"/>
          <p:nvPr/>
        </p:nvSpPr>
        <p:spPr>
          <a:xfrm>
            <a:off x="8207007" y="195780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8A03301-BCE1-05D3-BD15-8266FA6E0167}"/>
              </a:ext>
            </a:extLst>
          </p:cNvPr>
          <p:cNvCxnSpPr/>
          <p:nvPr/>
        </p:nvCxnSpPr>
        <p:spPr>
          <a:xfrm>
            <a:off x="8233898" y="2277983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128CF77-EF2D-7174-D11B-E078CED3ABB7}"/>
              </a:ext>
            </a:extLst>
          </p:cNvPr>
          <p:cNvSpPr txBox="1"/>
          <p:nvPr/>
        </p:nvSpPr>
        <p:spPr>
          <a:xfrm>
            <a:off x="11196471" y="384058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46CAB05-B4E9-79DC-B1D7-3F50C86DAD70}"/>
              </a:ext>
            </a:extLst>
          </p:cNvPr>
          <p:cNvSpPr txBox="1"/>
          <p:nvPr/>
        </p:nvSpPr>
        <p:spPr>
          <a:xfrm>
            <a:off x="11196471" y="348745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BFDE38-A465-23DF-75A4-111FF8B7286E}"/>
              </a:ext>
            </a:extLst>
          </p:cNvPr>
          <p:cNvSpPr txBox="1"/>
          <p:nvPr/>
        </p:nvSpPr>
        <p:spPr>
          <a:xfrm>
            <a:off x="11196471" y="3221113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8A608DC-39B3-93FD-CD4C-CAFABE727CF2}"/>
              </a:ext>
            </a:extLst>
          </p:cNvPr>
          <p:cNvSpPr txBox="1"/>
          <p:nvPr/>
        </p:nvSpPr>
        <p:spPr>
          <a:xfrm>
            <a:off x="422825" y="1060809"/>
            <a:ext cx="5877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mmunoblot against SCD 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pha Diagnostic International Inc., #SCD11-A, 1:100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9945F6-07FE-3AB7-B472-76FF626C9FB1}"/>
              </a:ext>
            </a:extLst>
          </p:cNvPr>
          <p:cNvSpPr txBox="1"/>
          <p:nvPr/>
        </p:nvSpPr>
        <p:spPr>
          <a:xfrm>
            <a:off x="6970787" y="1060809"/>
            <a:ext cx="41672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against vinculin</a:t>
            </a:r>
          </a:p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:2000, Merck, # SAB420008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F399273-B1F4-4778-2EC1-4B3E63C98C99}"/>
              </a:ext>
            </a:extLst>
          </p:cNvPr>
          <p:cNvSpPr txBox="1"/>
          <p:nvPr/>
        </p:nvSpPr>
        <p:spPr>
          <a:xfrm>
            <a:off x="422825" y="41358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E4933A1-90D0-FAD4-460F-A344627B7CFF}"/>
              </a:ext>
            </a:extLst>
          </p:cNvPr>
          <p:cNvSpPr txBox="1"/>
          <p:nvPr/>
        </p:nvSpPr>
        <p:spPr>
          <a:xfrm>
            <a:off x="11189" y="4506725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B572620D-002A-DFF3-698D-03976D638141}"/>
              </a:ext>
            </a:extLst>
          </p:cNvPr>
          <p:cNvCxnSpPr/>
          <p:nvPr/>
        </p:nvCxnSpPr>
        <p:spPr>
          <a:xfrm>
            <a:off x="639178" y="4714510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21206023-A4CD-2F1B-F811-AB64CEA898DC}"/>
              </a:ext>
            </a:extLst>
          </p:cNvPr>
          <p:cNvSpPr txBox="1"/>
          <p:nvPr/>
        </p:nvSpPr>
        <p:spPr>
          <a:xfrm>
            <a:off x="6215743" y="3381441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D4EB3D19-93EB-294E-7E31-54E799AE7383}"/>
              </a:ext>
            </a:extLst>
          </p:cNvPr>
          <p:cNvCxnSpPr/>
          <p:nvPr/>
        </p:nvCxnSpPr>
        <p:spPr>
          <a:xfrm>
            <a:off x="7099373" y="3589226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2165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lose up of a white object&#10;&#10;Description automatically generated">
            <a:extLst>
              <a:ext uri="{FF2B5EF4-FFF2-40B4-BE49-F238E27FC236}">
                <a16:creationId xmlns:a16="http://schemas.microsoft.com/office/drawing/2014/main" id="{6EC32DB5-95B3-756C-C924-56CBA957AB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7637" y="2461115"/>
            <a:ext cx="3220563" cy="595104"/>
          </a:xfrm>
          <a:prstGeom prst="rect">
            <a:avLst/>
          </a:prstGeom>
        </p:spPr>
      </p:pic>
      <p:pic>
        <p:nvPicPr>
          <p:cNvPr id="9" name="Picture 8" descr="A close-up of a dna&#10;&#10;Description automatically generated">
            <a:extLst>
              <a:ext uri="{FF2B5EF4-FFF2-40B4-BE49-F238E27FC236}">
                <a16:creationId xmlns:a16="http://schemas.microsoft.com/office/drawing/2014/main" id="{298F9BBC-ACF5-D287-5873-65EBD9BAFF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399" y="2423652"/>
            <a:ext cx="3600450" cy="42672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C64E34F-6FF8-894A-D6A6-B62BFD318698}"/>
              </a:ext>
            </a:extLst>
          </p:cNvPr>
          <p:cNvSpPr txBox="1"/>
          <p:nvPr/>
        </p:nvSpPr>
        <p:spPr>
          <a:xfrm>
            <a:off x="4286849" y="274883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B3BC4F-E78C-45A4-1917-475F87E605BF}"/>
              </a:ext>
            </a:extLst>
          </p:cNvPr>
          <p:cNvSpPr txBox="1"/>
          <p:nvPr/>
        </p:nvSpPr>
        <p:spPr>
          <a:xfrm>
            <a:off x="4286849" y="322251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0ED5CD-DAEC-9BCA-5E4F-2543507E9928}"/>
              </a:ext>
            </a:extLst>
          </p:cNvPr>
          <p:cNvSpPr txBox="1"/>
          <p:nvPr/>
        </p:nvSpPr>
        <p:spPr>
          <a:xfrm>
            <a:off x="4286847" y="381321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C0C14B9-C5AE-F2DB-364B-4FBE7629115F}"/>
              </a:ext>
            </a:extLst>
          </p:cNvPr>
          <p:cNvSpPr txBox="1"/>
          <p:nvPr/>
        </p:nvSpPr>
        <p:spPr>
          <a:xfrm>
            <a:off x="4286848" y="425813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BDBB39-4D79-7536-C02C-54B4BE98E640}"/>
              </a:ext>
            </a:extLst>
          </p:cNvPr>
          <p:cNvSpPr txBox="1"/>
          <p:nvPr/>
        </p:nvSpPr>
        <p:spPr>
          <a:xfrm>
            <a:off x="4298790" y="489595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3AC8FB-70E1-DAB5-FAFE-2089EBFAECD5}"/>
              </a:ext>
            </a:extLst>
          </p:cNvPr>
          <p:cNvSpPr txBox="1"/>
          <p:nvPr/>
        </p:nvSpPr>
        <p:spPr>
          <a:xfrm>
            <a:off x="1759038" y="208657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249D36-F532-DC67-93EC-4290080BE3BE}"/>
              </a:ext>
            </a:extLst>
          </p:cNvPr>
          <p:cNvSpPr txBox="1"/>
          <p:nvPr/>
        </p:nvSpPr>
        <p:spPr>
          <a:xfrm>
            <a:off x="2266336" y="208657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74D8523-5F7D-DE4E-B08D-DEA2CBF9DFD8}"/>
              </a:ext>
            </a:extLst>
          </p:cNvPr>
          <p:cNvSpPr txBox="1"/>
          <p:nvPr/>
        </p:nvSpPr>
        <p:spPr>
          <a:xfrm>
            <a:off x="2758583" y="208657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8E3AC2-2E42-1C0A-FDB3-39181A2BC900}"/>
              </a:ext>
            </a:extLst>
          </p:cNvPr>
          <p:cNvSpPr txBox="1"/>
          <p:nvPr/>
        </p:nvSpPr>
        <p:spPr>
          <a:xfrm>
            <a:off x="1850452" y="1766394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A49CBC6-13E6-AAF8-887A-D647301FAEBF}"/>
              </a:ext>
            </a:extLst>
          </p:cNvPr>
          <p:cNvCxnSpPr/>
          <p:nvPr/>
        </p:nvCxnSpPr>
        <p:spPr>
          <a:xfrm>
            <a:off x="1877343" y="2086575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D07B818-B109-92D7-899E-7B854F4C0A11}"/>
              </a:ext>
            </a:extLst>
          </p:cNvPr>
          <p:cNvSpPr txBox="1"/>
          <p:nvPr/>
        </p:nvSpPr>
        <p:spPr>
          <a:xfrm>
            <a:off x="8125425" y="211083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67A4298-71D9-7176-AE09-9DA87BD2D13C}"/>
              </a:ext>
            </a:extLst>
          </p:cNvPr>
          <p:cNvSpPr txBox="1"/>
          <p:nvPr/>
        </p:nvSpPr>
        <p:spPr>
          <a:xfrm>
            <a:off x="8632723" y="211083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B72D8B8-0BB9-2641-9942-7328593A5288}"/>
              </a:ext>
            </a:extLst>
          </p:cNvPr>
          <p:cNvSpPr txBox="1"/>
          <p:nvPr/>
        </p:nvSpPr>
        <p:spPr>
          <a:xfrm>
            <a:off x="9124970" y="211083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A6FED64-F2E1-1F5F-1895-D06D7AF6C3BF}"/>
              </a:ext>
            </a:extLst>
          </p:cNvPr>
          <p:cNvSpPr txBox="1"/>
          <p:nvPr/>
        </p:nvSpPr>
        <p:spPr>
          <a:xfrm>
            <a:off x="8216839" y="1790654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8A03301-BCE1-05D3-BD15-8266FA6E0167}"/>
              </a:ext>
            </a:extLst>
          </p:cNvPr>
          <p:cNvCxnSpPr/>
          <p:nvPr/>
        </p:nvCxnSpPr>
        <p:spPr>
          <a:xfrm>
            <a:off x="8243730" y="2110835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46CAB05-B4E9-79DC-B1D7-3F50C86DAD70}"/>
              </a:ext>
            </a:extLst>
          </p:cNvPr>
          <p:cNvSpPr txBox="1"/>
          <p:nvPr/>
        </p:nvSpPr>
        <p:spPr>
          <a:xfrm>
            <a:off x="6286787" y="2748835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BFDE38-A465-23DF-75A4-111FF8B7286E}"/>
              </a:ext>
            </a:extLst>
          </p:cNvPr>
          <p:cNvSpPr txBox="1"/>
          <p:nvPr/>
        </p:nvSpPr>
        <p:spPr>
          <a:xfrm>
            <a:off x="6306581" y="2480168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8A608DC-39B3-93FD-CD4C-CAFABE727CF2}"/>
              </a:ext>
            </a:extLst>
          </p:cNvPr>
          <p:cNvSpPr txBox="1"/>
          <p:nvPr/>
        </p:nvSpPr>
        <p:spPr>
          <a:xfrm>
            <a:off x="432657" y="893661"/>
            <a:ext cx="5877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mmunoblot against SCD 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pha Diagnostic International Inc., #SCD11-A, 1:100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9945F6-07FE-3AB7-B472-76FF626C9FB1}"/>
              </a:ext>
            </a:extLst>
          </p:cNvPr>
          <p:cNvSpPr txBox="1"/>
          <p:nvPr/>
        </p:nvSpPr>
        <p:spPr>
          <a:xfrm>
            <a:off x="6980619" y="893661"/>
            <a:ext cx="41672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against vinculin</a:t>
            </a:r>
          </a:p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:2000, Merck, # SAB420008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F399273-B1F4-4778-2EC1-4B3E63C98C99}"/>
              </a:ext>
            </a:extLst>
          </p:cNvPr>
          <p:cNvSpPr txBox="1"/>
          <p:nvPr/>
        </p:nvSpPr>
        <p:spPr>
          <a:xfrm>
            <a:off x="422825" y="41358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EE3E40-CD54-99DF-D01C-05B1608D6AA3}"/>
              </a:ext>
            </a:extLst>
          </p:cNvPr>
          <p:cNvSpPr txBox="1"/>
          <p:nvPr/>
        </p:nvSpPr>
        <p:spPr>
          <a:xfrm>
            <a:off x="96667" y="3407182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4A6A84F-C5CF-6220-E1A5-233725EB21D0}"/>
              </a:ext>
            </a:extLst>
          </p:cNvPr>
          <p:cNvCxnSpPr/>
          <p:nvPr/>
        </p:nvCxnSpPr>
        <p:spPr>
          <a:xfrm>
            <a:off x="724656" y="3614967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EA0885A1-590B-5020-A4A3-55BF71268CF3}"/>
              </a:ext>
            </a:extLst>
          </p:cNvPr>
          <p:cNvSpPr txBox="1"/>
          <p:nvPr/>
        </p:nvSpPr>
        <p:spPr>
          <a:xfrm flipH="1">
            <a:off x="10219208" y="2692099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80B2E72-5A81-B2DE-3FB6-8F5BE17EB2CA}"/>
              </a:ext>
            </a:extLst>
          </p:cNvPr>
          <p:cNvCxnSpPr>
            <a:cxnSpLocks/>
          </p:cNvCxnSpPr>
          <p:nvPr/>
        </p:nvCxnSpPr>
        <p:spPr>
          <a:xfrm flipH="1">
            <a:off x="9993064" y="2888828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4393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blurry image of a person's face&#10;&#10;Description automatically generated">
            <a:extLst>
              <a:ext uri="{FF2B5EF4-FFF2-40B4-BE49-F238E27FC236}">
                <a16:creationId xmlns:a16="http://schemas.microsoft.com/office/drawing/2014/main" id="{1A755589-F12D-CAB9-9251-AE4D7FCB82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060410" y="2584606"/>
            <a:ext cx="1809750" cy="1228725"/>
          </a:xfrm>
          <a:prstGeom prst="rect">
            <a:avLst/>
          </a:prstGeom>
        </p:spPr>
      </p:pic>
      <p:pic>
        <p:nvPicPr>
          <p:cNvPr id="11" name="Picture 10" descr="A close-up of a dna test&#10;&#10;Description automatically generated">
            <a:extLst>
              <a:ext uri="{FF2B5EF4-FFF2-40B4-BE49-F238E27FC236}">
                <a16:creationId xmlns:a16="http://schemas.microsoft.com/office/drawing/2014/main" id="{4E3D1B7B-C8C5-8FDE-FB7C-FDF817B5E4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72217" y="2574831"/>
            <a:ext cx="3238500" cy="306705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C64E34F-6FF8-894A-D6A6-B62BFD318698}"/>
              </a:ext>
            </a:extLst>
          </p:cNvPr>
          <p:cNvSpPr txBox="1"/>
          <p:nvPr/>
        </p:nvSpPr>
        <p:spPr>
          <a:xfrm>
            <a:off x="288732" y="270182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B3BC4F-E78C-45A4-1917-475F87E605BF}"/>
              </a:ext>
            </a:extLst>
          </p:cNvPr>
          <p:cNvSpPr txBox="1"/>
          <p:nvPr/>
        </p:nvSpPr>
        <p:spPr>
          <a:xfrm>
            <a:off x="288728" y="323690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0ED5CD-DAEC-9BCA-5E4F-2543507E9928}"/>
              </a:ext>
            </a:extLst>
          </p:cNvPr>
          <p:cNvSpPr txBox="1"/>
          <p:nvPr/>
        </p:nvSpPr>
        <p:spPr>
          <a:xfrm>
            <a:off x="288728" y="382182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C0C14B9-C5AE-F2DB-364B-4FBE7629115F}"/>
              </a:ext>
            </a:extLst>
          </p:cNvPr>
          <p:cNvSpPr txBox="1"/>
          <p:nvPr/>
        </p:nvSpPr>
        <p:spPr>
          <a:xfrm>
            <a:off x="288728" y="435690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BDBB39-4D79-7536-C02C-54B4BE98E640}"/>
              </a:ext>
            </a:extLst>
          </p:cNvPr>
          <p:cNvSpPr txBox="1"/>
          <p:nvPr/>
        </p:nvSpPr>
        <p:spPr>
          <a:xfrm>
            <a:off x="288729" y="500322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3AC8FB-70E1-DAB5-FAFE-2089EBFAECD5}"/>
              </a:ext>
            </a:extLst>
          </p:cNvPr>
          <p:cNvSpPr txBox="1"/>
          <p:nvPr/>
        </p:nvSpPr>
        <p:spPr>
          <a:xfrm>
            <a:off x="2146455" y="222422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249D36-F532-DC67-93EC-4290080BE3BE}"/>
              </a:ext>
            </a:extLst>
          </p:cNvPr>
          <p:cNvSpPr txBox="1"/>
          <p:nvPr/>
        </p:nvSpPr>
        <p:spPr>
          <a:xfrm>
            <a:off x="2653753" y="222422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74D8523-5F7D-DE4E-B08D-DEA2CBF9DFD8}"/>
              </a:ext>
            </a:extLst>
          </p:cNvPr>
          <p:cNvSpPr txBox="1"/>
          <p:nvPr/>
        </p:nvSpPr>
        <p:spPr>
          <a:xfrm>
            <a:off x="3146000" y="2224227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8E3AC2-2E42-1C0A-FDB3-39181A2BC900}"/>
              </a:ext>
            </a:extLst>
          </p:cNvPr>
          <p:cNvSpPr txBox="1"/>
          <p:nvPr/>
        </p:nvSpPr>
        <p:spPr>
          <a:xfrm>
            <a:off x="2237869" y="190404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A49CBC6-13E6-AAF8-887A-D647301FAEBF}"/>
              </a:ext>
            </a:extLst>
          </p:cNvPr>
          <p:cNvCxnSpPr/>
          <p:nvPr/>
        </p:nvCxnSpPr>
        <p:spPr>
          <a:xfrm>
            <a:off x="2264760" y="2224226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D07B818-B109-92D7-899E-7B854F4C0A11}"/>
              </a:ext>
            </a:extLst>
          </p:cNvPr>
          <p:cNvSpPr txBox="1"/>
          <p:nvPr/>
        </p:nvSpPr>
        <p:spPr>
          <a:xfrm>
            <a:off x="8115593" y="227798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67A4298-71D9-7176-AE09-9DA87BD2D13C}"/>
              </a:ext>
            </a:extLst>
          </p:cNvPr>
          <p:cNvSpPr txBox="1"/>
          <p:nvPr/>
        </p:nvSpPr>
        <p:spPr>
          <a:xfrm>
            <a:off x="8622891" y="227798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B72D8B8-0BB9-2641-9942-7328593A5288}"/>
              </a:ext>
            </a:extLst>
          </p:cNvPr>
          <p:cNvSpPr txBox="1"/>
          <p:nvPr/>
        </p:nvSpPr>
        <p:spPr>
          <a:xfrm>
            <a:off x="9115138" y="227798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A6FED64-F2E1-1F5F-1895-D06D7AF6C3BF}"/>
              </a:ext>
            </a:extLst>
          </p:cNvPr>
          <p:cNvSpPr txBox="1"/>
          <p:nvPr/>
        </p:nvSpPr>
        <p:spPr>
          <a:xfrm>
            <a:off x="8207007" y="195780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8A03301-BCE1-05D3-BD15-8266FA6E0167}"/>
              </a:ext>
            </a:extLst>
          </p:cNvPr>
          <p:cNvCxnSpPr/>
          <p:nvPr/>
        </p:nvCxnSpPr>
        <p:spPr>
          <a:xfrm>
            <a:off x="8233898" y="2277983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46CAB05-B4E9-79DC-B1D7-3F50C86DAD70}"/>
              </a:ext>
            </a:extLst>
          </p:cNvPr>
          <p:cNvSpPr txBox="1"/>
          <p:nvPr/>
        </p:nvSpPr>
        <p:spPr>
          <a:xfrm>
            <a:off x="6988295" y="291315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BFDE38-A465-23DF-75A4-111FF8B7286E}"/>
              </a:ext>
            </a:extLst>
          </p:cNvPr>
          <p:cNvSpPr txBox="1"/>
          <p:nvPr/>
        </p:nvSpPr>
        <p:spPr>
          <a:xfrm>
            <a:off x="6975850" y="2596934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8A608DC-39B3-93FD-CD4C-CAFABE727CF2}"/>
              </a:ext>
            </a:extLst>
          </p:cNvPr>
          <p:cNvSpPr txBox="1"/>
          <p:nvPr/>
        </p:nvSpPr>
        <p:spPr>
          <a:xfrm>
            <a:off x="422825" y="1060809"/>
            <a:ext cx="5877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mmunoblot against SCD 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pha Diagnostic International Inc., #SCD11-A, 1:100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9945F6-07FE-3AB7-B472-76FF626C9FB1}"/>
              </a:ext>
            </a:extLst>
          </p:cNvPr>
          <p:cNvSpPr txBox="1"/>
          <p:nvPr/>
        </p:nvSpPr>
        <p:spPr>
          <a:xfrm>
            <a:off x="6970787" y="1060809"/>
            <a:ext cx="41672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against vinculin</a:t>
            </a:r>
          </a:p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:2000, Merck, # SAB420008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F399273-B1F4-4778-2EC1-4B3E63C98C99}"/>
              </a:ext>
            </a:extLst>
          </p:cNvPr>
          <p:cNvSpPr txBox="1"/>
          <p:nvPr/>
        </p:nvSpPr>
        <p:spPr>
          <a:xfrm>
            <a:off x="422825" y="41358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EE3E40-CD54-99DF-D01C-05B1608D6AA3}"/>
              </a:ext>
            </a:extLst>
          </p:cNvPr>
          <p:cNvSpPr txBox="1"/>
          <p:nvPr/>
        </p:nvSpPr>
        <p:spPr>
          <a:xfrm flipH="1">
            <a:off x="4082989" y="3371475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4A6A84F-C5CF-6220-E1A5-233725EB21D0}"/>
              </a:ext>
            </a:extLst>
          </p:cNvPr>
          <p:cNvCxnSpPr>
            <a:cxnSpLocks/>
          </p:cNvCxnSpPr>
          <p:nvPr/>
        </p:nvCxnSpPr>
        <p:spPr>
          <a:xfrm flipH="1">
            <a:off x="3848485" y="3555647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EA0885A1-590B-5020-A4A3-55BF71268CF3}"/>
              </a:ext>
            </a:extLst>
          </p:cNvPr>
          <p:cNvSpPr txBox="1"/>
          <p:nvPr/>
        </p:nvSpPr>
        <p:spPr>
          <a:xfrm flipH="1">
            <a:off x="10111053" y="2859247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80B2E72-5A81-B2DE-3FB6-8F5BE17EB2CA}"/>
              </a:ext>
            </a:extLst>
          </p:cNvPr>
          <p:cNvCxnSpPr>
            <a:cxnSpLocks/>
          </p:cNvCxnSpPr>
          <p:nvPr/>
        </p:nvCxnSpPr>
        <p:spPr>
          <a:xfrm flipH="1">
            <a:off x="9884909" y="3055976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518E37E6-16CD-269C-11FF-D448E8CDD9BC}"/>
              </a:ext>
            </a:extLst>
          </p:cNvPr>
          <p:cNvSpPr txBox="1"/>
          <p:nvPr/>
        </p:nvSpPr>
        <p:spPr>
          <a:xfrm>
            <a:off x="7002415" y="328249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6939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76</Words>
  <Application>Microsoft Office PowerPoint</Application>
  <PresentationFormat>Widescreen</PresentationFormat>
  <Paragraphs>7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</cp:revision>
  <dcterms:created xsi:type="dcterms:W3CDTF">2024-06-19T15:40:59Z</dcterms:created>
  <dcterms:modified xsi:type="dcterms:W3CDTF">2024-06-19T15:58:12Z</dcterms:modified>
</cp:coreProperties>
</file>